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9" autoAdjust="0"/>
    <p:restoredTop sz="94660"/>
  </p:normalViewPr>
  <p:slideViewPr>
    <p:cSldViewPr snapToGrid="0">
      <p:cViewPr varScale="1">
        <p:scale>
          <a:sx n="50" d="100"/>
          <a:sy n="50" d="100"/>
        </p:scale>
        <p:origin x="34" y="5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741F3E-5260-4C91-A1B6-46977E6AADF6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EA143A-3A57-4F6F-A5F4-979DC29174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2207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FFCE86-947C-4DE7-8130-AE546BCC76D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4772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7886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501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623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614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0654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558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0956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7137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2512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0627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6772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E9F956-EDDB-417E-960C-546CD30B5F18}" type="datetimeFigureOut">
              <a:rPr lang="en-GB" smtClean="0"/>
              <a:t>11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4F2F25-9693-4762-99FD-383BD38167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7762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4197361" y="434330"/>
          <a:ext cx="4204361" cy="54686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3387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4880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5992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46176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476623"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. to Figure 4B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cluster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F infestation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development</a:t>
                      </a:r>
                    </a:p>
                  </a:txBody>
                  <a:tcPr marL="63305" marR="63305" marT="31652" marB="31652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974694">
                <a:tc>
                  <a:txBody>
                    <a:bodyPr/>
                    <a:lstStyle/>
                    <a:p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ringin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974694"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O-p-Coumaroylquinic acid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97469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chin</a:t>
                      </a: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Epicatechin_5min</a:t>
                      </a:r>
                    </a:p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089426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rhamnetin-3-O-rutinoside</a:t>
                      </a:r>
                    </a:p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978481"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cetin </a:t>
                      </a:r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ntoside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73774" y="1007336"/>
            <a:ext cx="1216178" cy="78108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71011" y="1084144"/>
            <a:ext cx="1242544" cy="71187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90684" y="1976563"/>
            <a:ext cx="1216178" cy="87665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75766" y="2128278"/>
            <a:ext cx="1242544" cy="711872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73773" y="2992318"/>
            <a:ext cx="1216178" cy="800857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97396" y="3000758"/>
            <a:ext cx="1242544" cy="83710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90684" y="4055744"/>
            <a:ext cx="1216178" cy="81074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75766" y="4170858"/>
            <a:ext cx="1242544" cy="682211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626142" y="5037323"/>
            <a:ext cx="1216178" cy="843701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051181" y="5087739"/>
            <a:ext cx="1242544" cy="79096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E03844EA-C3AC-4DE1-8227-02E5619B18D0}"/>
              </a:ext>
            </a:extLst>
          </p:cNvPr>
          <p:cNvSpPr txBox="1"/>
          <p:nvPr/>
        </p:nvSpPr>
        <p:spPr>
          <a:xfrm>
            <a:off x="451821" y="537882"/>
            <a:ext cx="2883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9: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7244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4260028" y="1259956"/>
          <a:ext cx="4055633" cy="348363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8003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9376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2637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35546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536574"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. to Figure 4B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cluster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F infestation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development</a:t>
                      </a:r>
                    </a:p>
                  </a:txBody>
                  <a:tcPr marL="63305" marR="63305" marT="31652" marB="31652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982353">
                <a:tc>
                  <a:txBody>
                    <a:bodyPr/>
                    <a:lstStyle/>
                    <a:p>
                      <a:pPr algn="l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-7.1min-471.111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982353">
                <a:tc>
                  <a:txBody>
                    <a:bodyPr/>
                    <a:lstStyle/>
                    <a:p>
                      <a:pPr algn="l"/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cin</a:t>
                      </a: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O-</a:t>
                      </a:r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xoside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detected</a:t>
                      </a: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982353">
                <a:tc>
                  <a:txBody>
                    <a:bodyPr/>
                    <a:lstStyle/>
                    <a:p>
                      <a:pPr algn="l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-17.4min-664.262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4428" y="1926214"/>
            <a:ext cx="1216178" cy="81404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26750" y="1969062"/>
            <a:ext cx="1242544" cy="77119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03670" y="2913804"/>
            <a:ext cx="1216178" cy="81733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57454" y="3883184"/>
            <a:ext cx="1216178" cy="81733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90319" y="3875206"/>
            <a:ext cx="1242544" cy="82063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E03844EA-C3AC-4DE1-8227-02E5619B18D0}"/>
              </a:ext>
            </a:extLst>
          </p:cNvPr>
          <p:cNvSpPr txBox="1"/>
          <p:nvPr/>
        </p:nvSpPr>
        <p:spPr>
          <a:xfrm>
            <a:off x="451821" y="537882"/>
            <a:ext cx="2883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9: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6848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4276968" y="1151073"/>
          <a:ext cx="3952632" cy="343722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022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9663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18334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31243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505610"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. to Figure 4B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cluster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F infestation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development</a:t>
                      </a:r>
                    </a:p>
                  </a:txBody>
                  <a:tcPr marL="63305" marR="63305" marT="31652" marB="31652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90620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ocatechoyl</a:t>
                      </a: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exose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90620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loyl</a:t>
                      </a: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exose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01287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kaempferol</a:t>
                      </a: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xoside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detected</a:t>
                      </a:r>
                    </a:p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25181" y="1901667"/>
            <a:ext cx="1216178" cy="67232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4207" y="1799500"/>
            <a:ext cx="1242544" cy="774491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25180" y="2753921"/>
            <a:ext cx="1216178" cy="827223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64207" y="2760513"/>
            <a:ext cx="1242544" cy="82063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25180" y="3705715"/>
            <a:ext cx="1216178" cy="75801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E03844EA-C3AC-4DE1-8227-02E5619B18D0}"/>
              </a:ext>
            </a:extLst>
          </p:cNvPr>
          <p:cNvSpPr txBox="1"/>
          <p:nvPr/>
        </p:nvSpPr>
        <p:spPr>
          <a:xfrm>
            <a:off x="451821" y="537882"/>
            <a:ext cx="2883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9: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41222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4416817" y="1087832"/>
          <a:ext cx="4092482" cy="46900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8712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5237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9751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35546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472028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. to Figure 4B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cluster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F infestation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development</a:t>
                      </a:r>
                    </a:p>
                  </a:txBody>
                  <a:tcPr marL="63305" marR="63305" marT="31652" marB="31652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202788">
                <a:tc>
                  <a:txBody>
                    <a:bodyPr/>
                    <a:lstStyle/>
                    <a:p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umenol</a:t>
                      </a: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 hexoside-FA_10min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906204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ydroxy-blumenol</a:t>
                      </a:r>
                      <a:r>
                        <a:rPr lang="en-GB" sz="120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 </a:t>
                      </a:r>
                      <a:r>
                        <a:rPr lang="en-GB" sz="120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exoside</a:t>
                      </a:r>
                      <a:r>
                        <a:rPr lang="en-GB" sz="120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FA</a:t>
                      </a: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594" marR="6594" marT="6594" marB="0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detected</a:t>
                      </a: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906204">
                <a:tc>
                  <a:txBody>
                    <a:bodyPr/>
                    <a:lstStyle/>
                    <a:p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uloyl</a:t>
                      </a: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alate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202788">
                <a:tc>
                  <a:txBody>
                    <a:bodyPr/>
                    <a:lstStyle/>
                    <a:p>
                      <a:r>
                        <a:rPr lang="en-GB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avonol</a:t>
                      </a:r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risaccharide-8.9min-755.2034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305" marR="63305" marT="31652" marB="31652" anchor="ctr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tc>
                  <a:txBody>
                    <a:bodyPr/>
                    <a:lstStyle/>
                    <a:p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3305" marR="63305" marT="31652" marB="31652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4969" y="1843018"/>
            <a:ext cx="1216178" cy="711872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95483" y="1802163"/>
            <a:ext cx="1242544" cy="74153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54969" y="2807000"/>
            <a:ext cx="1216178" cy="81074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54968" y="3701834"/>
            <a:ext cx="1216178" cy="84370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06241" y="3761489"/>
            <a:ext cx="1242544" cy="78767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54968" y="4808623"/>
            <a:ext cx="1216178" cy="78108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27757" y="4852152"/>
            <a:ext cx="1242544" cy="70528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E03844EA-C3AC-4DE1-8227-02E5619B18D0}"/>
              </a:ext>
            </a:extLst>
          </p:cNvPr>
          <p:cNvSpPr txBox="1"/>
          <p:nvPr/>
        </p:nvSpPr>
        <p:spPr>
          <a:xfrm>
            <a:off x="451821" y="537882"/>
            <a:ext cx="2883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9: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727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Office PowerPoint</Application>
  <PresentationFormat>Widescreen</PresentationFormat>
  <Paragraphs>54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rez, L</dc:creator>
  <cp:lastModifiedBy>Perez, L</cp:lastModifiedBy>
  <cp:revision>2</cp:revision>
  <dcterms:created xsi:type="dcterms:W3CDTF">2019-07-11T21:36:31Z</dcterms:created>
  <dcterms:modified xsi:type="dcterms:W3CDTF">2019-07-11T22:16:13Z</dcterms:modified>
</cp:coreProperties>
</file>